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5" autoAdjust="0"/>
    <p:restoredTop sz="94660"/>
  </p:normalViewPr>
  <p:slideViewPr>
    <p:cSldViewPr snapToGrid="0">
      <p:cViewPr>
        <p:scale>
          <a:sx n="87" d="100"/>
          <a:sy n="87" d="100"/>
        </p:scale>
        <p:origin x="60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44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11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427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79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905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269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795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857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150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797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168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0FCB69-AC0E-420B-BD38-DEA52D27B503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C327F-046C-4A74-823E-634FC2E78E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13" Type="http://schemas.openxmlformats.org/officeDocument/2006/relationships/image" Target="../media/image30.tiff"/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12" Type="http://schemas.openxmlformats.org/officeDocument/2006/relationships/image" Target="../media/image29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tiff"/><Relationship Id="rId11" Type="http://schemas.openxmlformats.org/officeDocument/2006/relationships/image" Target="../media/image28.tiff"/><Relationship Id="rId5" Type="http://schemas.openxmlformats.org/officeDocument/2006/relationships/image" Target="../media/image22.tiff"/><Relationship Id="rId15" Type="http://schemas.openxmlformats.org/officeDocument/2006/relationships/image" Target="../media/image32.tiff"/><Relationship Id="rId10" Type="http://schemas.openxmlformats.org/officeDocument/2006/relationships/image" Target="../media/image27.tiff"/><Relationship Id="rId4" Type="http://schemas.openxmlformats.org/officeDocument/2006/relationships/image" Target="../media/image21.tiff"/><Relationship Id="rId9" Type="http://schemas.openxmlformats.org/officeDocument/2006/relationships/image" Target="../media/image26.tiff"/><Relationship Id="rId14" Type="http://schemas.openxmlformats.org/officeDocument/2006/relationships/image" Target="../media/image31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3" Type="http://schemas.openxmlformats.org/officeDocument/2006/relationships/image" Target="../media/image34.tiff"/><Relationship Id="rId7" Type="http://schemas.openxmlformats.org/officeDocument/2006/relationships/image" Target="../media/image38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tiff"/><Relationship Id="rId11" Type="http://schemas.openxmlformats.org/officeDocument/2006/relationships/image" Target="../media/image42.tiff"/><Relationship Id="rId5" Type="http://schemas.openxmlformats.org/officeDocument/2006/relationships/image" Target="../media/image36.tiff"/><Relationship Id="rId10" Type="http://schemas.openxmlformats.org/officeDocument/2006/relationships/image" Target="../media/image41.tiff"/><Relationship Id="rId4" Type="http://schemas.openxmlformats.org/officeDocument/2006/relationships/image" Target="../media/image35.tiff"/><Relationship Id="rId9" Type="http://schemas.openxmlformats.org/officeDocument/2006/relationships/image" Target="../media/image4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6.tiff"/><Relationship Id="rId4" Type="http://schemas.openxmlformats.org/officeDocument/2006/relationships/image" Target="../media/image4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2" Type="http://schemas.openxmlformats.org/officeDocument/2006/relationships/image" Target="../media/image4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1.tiff"/><Relationship Id="rId5" Type="http://schemas.openxmlformats.org/officeDocument/2006/relationships/image" Target="../media/image50.tiff"/><Relationship Id="rId4" Type="http://schemas.openxmlformats.org/officeDocument/2006/relationships/image" Target="../media/image49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tiff"/><Relationship Id="rId3" Type="http://schemas.openxmlformats.org/officeDocument/2006/relationships/image" Target="../media/image53.tiff"/><Relationship Id="rId7" Type="http://schemas.openxmlformats.org/officeDocument/2006/relationships/image" Target="../media/image57.tiff"/><Relationship Id="rId2" Type="http://schemas.openxmlformats.org/officeDocument/2006/relationships/image" Target="../media/image52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6.tiff"/><Relationship Id="rId5" Type="http://schemas.openxmlformats.org/officeDocument/2006/relationships/image" Target="../media/image55.tiff"/><Relationship Id="rId4" Type="http://schemas.openxmlformats.org/officeDocument/2006/relationships/image" Target="../media/image54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tiff"/><Relationship Id="rId2" Type="http://schemas.openxmlformats.org/officeDocument/2006/relationships/image" Target="../media/image5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tiff"/><Relationship Id="rId5" Type="http://schemas.openxmlformats.org/officeDocument/2006/relationships/image" Target="../media/image62.tiff"/><Relationship Id="rId4" Type="http://schemas.openxmlformats.org/officeDocument/2006/relationships/image" Target="../media/image6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7320" y="191967"/>
            <a:ext cx="3236976" cy="100584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0260" y="180092"/>
            <a:ext cx="3233274" cy="100584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6" name="Picture 5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7320" y="1269611"/>
            <a:ext cx="3236976" cy="100584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8" name="Picture 7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462" y="1261101"/>
            <a:ext cx="3236976" cy="100584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9" name="Picture 8"/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282" y="3319175"/>
            <a:ext cx="3236976" cy="100584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0" name="Picture 9"/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0260" y="3312323"/>
            <a:ext cx="3236976" cy="100584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1" name="Picture 10"/>
          <p:cNvPicPr preferRelativeResize="0"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282" y="2340113"/>
            <a:ext cx="3236976" cy="91440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2" name="Picture 11"/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0260" y="2338745"/>
            <a:ext cx="3236976" cy="91440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3" name="Picture 12"/>
          <p:cNvPicPr preferRelativeResize="0"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495" y="4388966"/>
            <a:ext cx="3236976" cy="36576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4" name="Picture 13"/>
          <p:cNvPicPr preferRelativeResize="0"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462" y="4388966"/>
            <a:ext cx="3236976" cy="36576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5" name="Picture 14"/>
          <p:cNvPicPr preferRelativeResize="0"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282" y="4807437"/>
            <a:ext cx="3236976" cy="36576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6" name="Picture 15"/>
          <p:cNvPicPr preferRelativeResize="0"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462" y="4817970"/>
            <a:ext cx="3236976" cy="36576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7" name="Picture 16"/>
          <p:cNvPicPr preferRelativeResize="0"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282" y="5239790"/>
            <a:ext cx="3236976" cy="45720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462" y="5239014"/>
            <a:ext cx="3233928" cy="460248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20" name="Picture 19"/>
          <p:cNvPicPr preferRelativeResize="0"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7414" y="5775741"/>
            <a:ext cx="3236976" cy="50292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21" name="Picture 20"/>
          <p:cNvPicPr preferRelativeResize="0"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282" y="5775741"/>
            <a:ext cx="3236976" cy="502920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22" name="Picture 21"/>
          <p:cNvPicPr preferRelativeResize="0"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5282" y="6355140"/>
            <a:ext cx="3236976" cy="252984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  <p:pic>
        <p:nvPicPr>
          <p:cNvPr id="23" name="Picture 22"/>
          <p:cNvPicPr preferRelativeResize="0"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7414" y="6355140"/>
            <a:ext cx="3233928" cy="256032"/>
          </a:xfrm>
          <a:prstGeom prst="rect">
            <a:avLst/>
          </a:prstGeom>
          <a:ln w="3175">
            <a:solidFill>
              <a:schemeClr val="tx1"/>
            </a:solidFill>
            <a:prstDash val="solid"/>
          </a:ln>
        </p:spPr>
      </p:pic>
    </p:spTree>
    <p:extLst>
      <p:ext uri="{BB962C8B-B14F-4D97-AF65-F5344CB8AC3E}">
        <p14:creationId xmlns:p14="http://schemas.microsoft.com/office/powerpoint/2010/main" val="22301332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2139496" y="454313"/>
            <a:ext cx="6543456" cy="5506683"/>
            <a:chOff x="2139496" y="454313"/>
            <a:chExt cx="6543456" cy="5506683"/>
          </a:xfrm>
        </p:grpSpPr>
        <p:pic>
          <p:nvPicPr>
            <p:cNvPr id="2" name="Picture 1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6432" y="1020503"/>
              <a:ext cx="3236976" cy="64008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3" name="Picture 2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037" y="1020503"/>
              <a:ext cx="3236976" cy="64008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6432" y="454313"/>
              <a:ext cx="3236976" cy="5029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040" y="454314"/>
              <a:ext cx="3236976" cy="499385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6" name="Picture 5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5976" y="1723853"/>
              <a:ext cx="3236976" cy="5029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7" name="Picture 6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9496" y="1723853"/>
              <a:ext cx="3236976" cy="5029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8" name="Picture 7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5976" y="2288181"/>
              <a:ext cx="3236976" cy="64008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9" name="Picture 8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9496" y="2290043"/>
              <a:ext cx="3236976" cy="64008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0" name="Picture 9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5976" y="2995534"/>
              <a:ext cx="3236976" cy="100584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1" name="Picture 10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037" y="2995534"/>
              <a:ext cx="3236976" cy="100584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2" name="Picture 11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9496" y="4066785"/>
              <a:ext cx="3236976" cy="100584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3" name="Picture 12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5976" y="4066785"/>
              <a:ext cx="3236976" cy="100584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5" name="Picture 14"/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45976" y="5138036"/>
              <a:ext cx="3236976" cy="82296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6" name="Picture 15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9496" y="5138036"/>
              <a:ext cx="3236976" cy="82296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</p:grpSp>
    </p:spTree>
    <p:extLst>
      <p:ext uri="{BB962C8B-B14F-4D97-AF65-F5344CB8AC3E}">
        <p14:creationId xmlns:p14="http://schemas.microsoft.com/office/powerpoint/2010/main" val="2853264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613615" y="923254"/>
            <a:ext cx="6563892" cy="4632365"/>
            <a:chOff x="2690733" y="460546"/>
            <a:chExt cx="6563892" cy="4632365"/>
          </a:xfrm>
        </p:grpSpPr>
        <p:pic>
          <p:nvPicPr>
            <p:cNvPr id="2" name="Picture 1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2659" y="460546"/>
              <a:ext cx="3236976" cy="7315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3" name="Picture 2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0733" y="460546"/>
              <a:ext cx="3236976" cy="7315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2659" y="1291664"/>
              <a:ext cx="3236976" cy="100584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5" name="Picture 4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0733" y="1291664"/>
              <a:ext cx="3236976" cy="100584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6" name="Picture 5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2659" y="2382112"/>
              <a:ext cx="3236976" cy="109728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7" name="Picture 6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0733" y="2382112"/>
              <a:ext cx="3236976" cy="109728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5723" y="3530273"/>
              <a:ext cx="3236976" cy="5791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9" name="Picture 8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08253" y="3530273"/>
              <a:ext cx="3236976" cy="576072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0" name="Picture 9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17649" y="4178511"/>
              <a:ext cx="3236976" cy="91440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11" name="Picture 10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5723" y="4178511"/>
              <a:ext cx="3236976" cy="91440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</p:grpSp>
    </p:spTree>
    <p:extLst>
      <p:ext uri="{BB962C8B-B14F-4D97-AF65-F5344CB8AC3E}">
        <p14:creationId xmlns:p14="http://schemas.microsoft.com/office/powerpoint/2010/main" val="1633549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3144743" y="1935863"/>
            <a:ext cx="4061225" cy="1853117"/>
            <a:chOff x="3398131" y="1098582"/>
            <a:chExt cx="4061225" cy="1853117"/>
          </a:xfrm>
        </p:grpSpPr>
        <p:pic>
          <p:nvPicPr>
            <p:cNvPr id="2" name="Picture 1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2380" y="1521877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3" name="Picture 2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2380" y="1891209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4" name="TextBox 3"/>
            <p:cNvSpPr txBox="1"/>
            <p:nvPr/>
          </p:nvSpPr>
          <p:spPr>
            <a:xfrm>
              <a:off x="3492709" y="1521877"/>
              <a:ext cx="5831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AD</a:t>
              </a:r>
              <a:endParaRPr 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398131" y="1841167"/>
              <a:ext cx="772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-BAD</a:t>
              </a:r>
              <a:endParaRPr lang="en-US" dirty="0"/>
            </a:p>
          </p:txBody>
        </p:sp>
        <p:pic>
          <p:nvPicPr>
            <p:cNvPr id="6" name="Picture 5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2380" y="2260541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3548173" y="2213035"/>
              <a:ext cx="5277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JNK</a:t>
              </a:r>
              <a:endParaRPr lang="en-US" dirty="0"/>
            </a:p>
          </p:txBody>
        </p:sp>
        <p:pic>
          <p:nvPicPr>
            <p:cNvPr id="8" name="Picture 7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22380" y="2637256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3398131" y="2582367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GAPDH</a:t>
              </a:r>
              <a:endParaRPr lang="en-US" dirty="0"/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4222380" y="1417626"/>
              <a:ext cx="175869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6070294" y="1417626"/>
              <a:ext cx="138906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4705772" y="1100420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ON</a:t>
              </a:r>
              <a:endParaRPr 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444600" y="1098582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EVIV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155967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3021600" y="1836715"/>
            <a:ext cx="4140359" cy="2107228"/>
            <a:chOff x="2129234" y="1858748"/>
            <a:chExt cx="4140359" cy="2107228"/>
          </a:xfrm>
        </p:grpSpPr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4115" y="2285688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2366707" y="2285688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KT</a:t>
              </a:r>
              <a:endParaRPr lang="en-US" dirty="0"/>
            </a:p>
          </p:txBody>
        </p:sp>
        <p:pic>
          <p:nvPicPr>
            <p:cNvPr id="6" name="Picture 5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4115" y="2619990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2306114" y="2560008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-AKT</a:t>
              </a:r>
              <a:endParaRPr lang="en-US" dirty="0"/>
            </a:p>
          </p:txBody>
        </p:sp>
        <p:pic>
          <p:nvPicPr>
            <p:cNvPr id="8" name="Picture 7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20640" y="3295662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2129234" y="3200650"/>
              <a:ext cx="9439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-MAPK</a:t>
              </a:r>
              <a:endParaRPr lang="en-US" dirty="0"/>
            </a:p>
          </p:txBody>
        </p:sp>
        <p:pic>
          <p:nvPicPr>
            <p:cNvPr id="10" name="Picture 9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04115" y="2967288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11" name="TextBox 10"/>
            <p:cNvSpPr txBox="1"/>
            <p:nvPr/>
          </p:nvSpPr>
          <p:spPr>
            <a:xfrm>
              <a:off x="2274023" y="2920972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MAPK</a:t>
              </a:r>
              <a:endParaRPr lang="en-US" dirty="0"/>
            </a:p>
          </p:txBody>
        </p:sp>
        <p:pic>
          <p:nvPicPr>
            <p:cNvPr id="12" name="Picture 11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32617" y="3634323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13" name="Rectangle 12"/>
            <p:cNvSpPr/>
            <p:nvPr/>
          </p:nvSpPr>
          <p:spPr>
            <a:xfrm>
              <a:off x="2166639" y="3596644"/>
              <a:ext cx="86914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>
                  <a:solidFill>
                    <a:srgbClr val="333333"/>
                  </a:solidFill>
                </a:rPr>
                <a:t>GAPDH</a:t>
              </a:r>
              <a:endParaRPr lang="en-US" b="0" i="0" dirty="0">
                <a:solidFill>
                  <a:srgbClr val="333333"/>
                </a:solidFill>
                <a:effectLst/>
              </a:endParaRPr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3021537" y="2177792"/>
              <a:ext cx="175869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4869451" y="2177792"/>
              <a:ext cx="138906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3471879" y="1860586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ON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210707" y="1858748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EVIV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989811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2192355" y="1748582"/>
            <a:ext cx="5086818" cy="2812220"/>
            <a:chOff x="1773714" y="1726549"/>
            <a:chExt cx="5086818" cy="2812220"/>
          </a:xfrm>
        </p:grpSpPr>
        <p:pic>
          <p:nvPicPr>
            <p:cNvPr id="2" name="Picture 1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3556" y="2515284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2776249" y="2490672"/>
              <a:ext cx="847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-BCL2</a:t>
              </a:r>
              <a:endParaRPr lang="en-US" dirty="0"/>
            </a:p>
          </p:txBody>
        </p:sp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3556" y="2145952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2776250" y="2122199"/>
              <a:ext cx="847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CL2</a:t>
              </a:r>
              <a:endParaRPr lang="en-US" dirty="0"/>
            </a:p>
          </p:txBody>
        </p:sp>
        <p:pic>
          <p:nvPicPr>
            <p:cNvPr id="6" name="Picture 5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3556" y="2884616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2638539" y="2837110"/>
              <a:ext cx="11227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aspase3</a:t>
              </a:r>
              <a:endParaRPr lang="en-US" dirty="0"/>
            </a:p>
          </p:txBody>
        </p:sp>
        <p:pic>
          <p:nvPicPr>
            <p:cNvPr id="9" name="Picture 8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3556" y="3572077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1773714" y="3529127"/>
              <a:ext cx="20050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leaved Caspase9</a:t>
              </a:r>
              <a:endParaRPr lang="en-US" dirty="0"/>
            </a:p>
          </p:txBody>
        </p:sp>
        <p:pic>
          <p:nvPicPr>
            <p:cNvPr id="11" name="Picture 10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3556" y="3222765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2638539" y="3182689"/>
              <a:ext cx="10721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aspase9</a:t>
              </a:r>
              <a:endParaRPr lang="en-US" dirty="0"/>
            </a:p>
          </p:txBody>
        </p:sp>
        <p:pic>
          <p:nvPicPr>
            <p:cNvPr id="13" name="Picture 12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3555" y="4216943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2687121" y="4169437"/>
              <a:ext cx="9364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GAPDH</a:t>
              </a:r>
              <a:endParaRPr lang="en-US" dirty="0"/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3594418" y="2045593"/>
              <a:ext cx="175869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5442332" y="2045593"/>
              <a:ext cx="138906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4044760" y="1728387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ON</a:t>
              </a:r>
              <a:endParaRPr lang="en-US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783588" y="1726549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EVIV</a:t>
              </a:r>
              <a:endParaRPr lang="en-US" dirty="0"/>
            </a:p>
          </p:txBody>
        </p:sp>
        <p:pic>
          <p:nvPicPr>
            <p:cNvPr id="20" name="Picture 19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178" y="3893483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25" name="TextBox 24"/>
            <p:cNvSpPr txBox="1"/>
            <p:nvPr/>
          </p:nvSpPr>
          <p:spPr>
            <a:xfrm>
              <a:off x="2857283" y="3875565"/>
              <a:ext cx="7371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AX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142481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3272009" y="1902813"/>
            <a:ext cx="4215163" cy="2142999"/>
            <a:chOff x="2302525" y="1407054"/>
            <a:chExt cx="4215163" cy="2142999"/>
          </a:xfrm>
        </p:grpSpPr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0712" y="2503327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5" name="Picture 4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0712" y="2867921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2302525" y="2455821"/>
              <a:ext cx="10906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VEGFR1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302525" y="2794943"/>
              <a:ext cx="10906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VEGFR2</a:t>
              </a:r>
              <a:endParaRPr lang="en-US" dirty="0"/>
            </a:p>
          </p:txBody>
        </p:sp>
        <p:pic>
          <p:nvPicPr>
            <p:cNvPr id="8" name="Picture 7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0712" y="2157072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pic>
          <p:nvPicPr>
            <p:cNvPr id="9" name="Picture 8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0712" y="1835246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2412694" y="1820729"/>
              <a:ext cx="10906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 smtClean="0"/>
                <a:t>eNOS</a:t>
              </a:r>
              <a:endParaRPr 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302525" y="2152467"/>
              <a:ext cx="10906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-</a:t>
              </a:r>
              <a:r>
                <a:rPr lang="en-US" dirty="0" err="1" smtClean="0"/>
                <a:t>eNOS</a:t>
              </a:r>
              <a:endParaRPr lang="en-US" dirty="0"/>
            </a:p>
          </p:txBody>
        </p:sp>
        <p:pic>
          <p:nvPicPr>
            <p:cNvPr id="13" name="Picture 12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0712" y="3228227"/>
              <a:ext cx="3236976" cy="274320"/>
            </a:xfrm>
            <a:prstGeom prst="rect">
              <a:avLst/>
            </a:prstGeom>
            <a:ln w="3175">
              <a:solidFill>
                <a:schemeClr val="tx1"/>
              </a:solidFill>
              <a:prstDash val="solid"/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2302525" y="3180721"/>
              <a:ext cx="109067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GAPDH</a:t>
              </a:r>
              <a:endParaRPr lang="en-US" dirty="0"/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3274928" y="1726098"/>
              <a:ext cx="175869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5122842" y="1726098"/>
              <a:ext cx="138906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3725270" y="1408892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ON</a:t>
              </a:r>
              <a:endParaRPr lang="en-US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464098" y="1407054"/>
              <a:ext cx="758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EVIV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374748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30</Words>
  <Application>Microsoft Office PowerPoint</Application>
  <PresentationFormat>Widescreen</PresentationFormat>
  <Paragraphs>2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ifespa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, Guangbin</dc:creator>
  <cp:lastModifiedBy>Shi, Guangbin</cp:lastModifiedBy>
  <cp:revision>19</cp:revision>
  <dcterms:created xsi:type="dcterms:W3CDTF">2020-06-25T13:20:11Z</dcterms:created>
  <dcterms:modified xsi:type="dcterms:W3CDTF">2020-06-25T17:52:05Z</dcterms:modified>
</cp:coreProperties>
</file>